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10.wmf" ContentType="image/x-wmf"/>
  <Override PartName="/ppt/media/image7.png" ContentType="image/png"/>
  <Override PartName="/ppt/media/image11.wmf" ContentType="image/x-wmf"/>
  <Override PartName="/ppt/media/image8.png" ContentType="image/png"/>
  <Override PartName="/ppt/media/image12.wmf" ContentType="image/x-wmf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CC36C-3C58-4A73-BC57-7DA1282075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9DE17C-CAF7-49F6-8567-4171274FBF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F8F79F-7613-4E7A-9DA5-A8A448D620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1ED08-A5E6-4246-8BC6-9D709B3189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69E93-8E06-4D35-98E0-D6ECF85940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A5A33-0371-4C78-9259-F735595161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EA7FA-D242-4F63-BED5-F2BF0AD9A4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68D26-7C18-483C-B238-CA45776418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270E5A-C673-4CC6-8E82-1CC4D2AC45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438C0-56A3-473F-BEFE-E5F3F56188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D9BFE-6EA3-4B12-A485-056308C108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EB0E0-C25A-4C64-BE53-6F82BCB7EC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th-TH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th-TH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FA1EF7-ACAD-4D04-964C-547C1432DE4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62080" y="720720"/>
            <a:ext cx="2874960" cy="1141560"/>
            <a:chOff x="262080" y="720720"/>
            <a:chExt cx="2874960" cy="114156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17012" t="13110" r="9356" b="8194"/>
            <a:stretch/>
          </p:blipFill>
          <p:spPr>
            <a:xfrm>
              <a:off x="262080" y="720720"/>
              <a:ext cx="934920" cy="86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329760" y="1611360"/>
              <a:ext cx="73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" descr=""/>
            <p:cNvPicPr/>
            <p:nvPr/>
          </p:nvPicPr>
          <p:blipFill>
            <a:blip r:embed="rId2"/>
            <a:srcRect l="15878" t="17012" r="10207" b="15027"/>
            <a:stretch/>
          </p:blipFill>
          <p:spPr>
            <a:xfrm>
              <a:off x="1228680" y="720720"/>
              <a:ext cx="938160" cy="86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"/>
            <p:cNvSpPr/>
            <p:nvPr/>
          </p:nvSpPr>
          <p:spPr>
            <a:xfrm>
              <a:off x="1143360" y="1616040"/>
              <a:ext cx="1029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Vehicle-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" descr=""/>
            <p:cNvPicPr/>
            <p:nvPr/>
          </p:nvPicPr>
          <p:blipFill>
            <a:blip r:embed="rId3"/>
            <a:srcRect l="22682" t="11173" r="3402" b="21788"/>
            <a:stretch/>
          </p:blipFill>
          <p:spPr>
            <a:xfrm>
              <a:off x="2197080" y="720720"/>
              <a:ext cx="939960" cy="86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2179800" y="1616040"/>
              <a:ext cx="88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HA-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>
            <a:off x="622800" y="37476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. falciparum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ring cultu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98560" y="374760"/>
            <a:ext cx="256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. falciparum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trophozoite cultu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031160" y="374760"/>
            <a:ext cx="23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. falciparum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schizont cultu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"/>
          <p:cNvGrpSpPr/>
          <p:nvPr/>
        </p:nvGrpSpPr>
        <p:grpSpPr>
          <a:xfrm>
            <a:off x="3548160" y="720720"/>
            <a:ext cx="2844720" cy="1120680"/>
            <a:chOff x="3548160" y="720720"/>
            <a:chExt cx="2844720" cy="1120680"/>
          </a:xfrm>
        </p:grpSpPr>
        <p:pic>
          <p:nvPicPr>
            <p:cNvPr id="52" name="" descr=""/>
            <p:cNvPicPr/>
            <p:nvPr/>
          </p:nvPicPr>
          <p:blipFill>
            <a:blip r:embed="rId4"/>
            <a:srcRect l="11341" t="17595" r="15027" b="12023"/>
            <a:stretch/>
          </p:blipFill>
          <p:spPr>
            <a:xfrm>
              <a:off x="3548160" y="720720"/>
              <a:ext cx="934920" cy="863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" descr=""/>
            <p:cNvPicPr/>
            <p:nvPr/>
          </p:nvPicPr>
          <p:blipFill>
            <a:blip r:embed="rId5"/>
            <a:srcRect l="9356" t="5936" r="17012" b="22855"/>
            <a:stretch/>
          </p:blipFill>
          <p:spPr>
            <a:xfrm>
              <a:off x="4503600" y="720720"/>
              <a:ext cx="935280" cy="863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" descr=""/>
            <p:cNvPicPr/>
            <p:nvPr/>
          </p:nvPicPr>
          <p:blipFill>
            <a:blip r:embed="rId6"/>
            <a:srcRect l="0" t="0" r="0" b="5512"/>
            <a:stretch/>
          </p:blipFill>
          <p:spPr>
            <a:xfrm>
              <a:off x="5457960" y="720720"/>
              <a:ext cx="934920" cy="863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"/>
            <p:cNvSpPr/>
            <p:nvPr/>
          </p:nvSpPr>
          <p:spPr>
            <a:xfrm>
              <a:off x="3619080" y="1590480"/>
              <a:ext cx="73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422960" y="1595160"/>
              <a:ext cx="1029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Vehicle-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445360" y="1595160"/>
              <a:ext cx="88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HA-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" name=""/>
          <p:cNvGrpSpPr/>
          <p:nvPr/>
        </p:nvGrpSpPr>
        <p:grpSpPr>
          <a:xfrm>
            <a:off x="6800760" y="720720"/>
            <a:ext cx="2854440" cy="1154160"/>
            <a:chOff x="6800760" y="720720"/>
            <a:chExt cx="2854440" cy="1154160"/>
          </a:xfrm>
        </p:grpSpPr>
        <p:pic>
          <p:nvPicPr>
            <p:cNvPr id="59" name="" descr=""/>
            <p:cNvPicPr/>
            <p:nvPr/>
          </p:nvPicPr>
          <p:blipFill>
            <a:blip r:embed="rId7"/>
            <a:srcRect l="17012" t="17012" r="9356" b="15027"/>
            <a:stretch/>
          </p:blipFill>
          <p:spPr>
            <a:xfrm>
              <a:off x="6800760" y="722160"/>
              <a:ext cx="93528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" descr=""/>
            <p:cNvPicPr/>
            <p:nvPr/>
          </p:nvPicPr>
          <p:blipFill>
            <a:blip r:embed="rId8"/>
            <a:srcRect l="15027" t="5964" r="11341" b="18832"/>
            <a:stretch/>
          </p:blipFill>
          <p:spPr>
            <a:xfrm>
              <a:off x="7751880" y="722160"/>
              <a:ext cx="93492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" descr=""/>
            <p:cNvPicPr/>
            <p:nvPr/>
          </p:nvPicPr>
          <p:blipFill>
            <a:blip r:embed="rId9"/>
            <a:srcRect l="21548" t="22913" r="8789" b="5964"/>
            <a:stretch/>
          </p:blipFill>
          <p:spPr>
            <a:xfrm>
              <a:off x="8718480" y="720720"/>
              <a:ext cx="936720" cy="86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"/>
            <p:cNvSpPr/>
            <p:nvPr/>
          </p:nvSpPr>
          <p:spPr>
            <a:xfrm>
              <a:off x="6878160" y="1623960"/>
              <a:ext cx="73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675920" y="1628640"/>
              <a:ext cx="1029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Vehicle-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8710920" y="1628640"/>
              <a:ext cx="88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HA-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5" name="" descr=""/>
          <p:cNvPicPr/>
          <p:nvPr/>
        </p:nvPicPr>
        <p:blipFill>
          <a:blip r:embed="rId10"/>
          <a:srcRect l="16655" t="17672" r="16655" b="33829"/>
          <a:stretch/>
        </p:blipFill>
        <p:spPr>
          <a:xfrm>
            <a:off x="190440" y="2521080"/>
            <a:ext cx="3009960" cy="309564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11"/>
          <a:srcRect l="20474" t="24401" r="11906" b="28438"/>
          <a:stretch/>
        </p:blipFill>
        <p:spPr>
          <a:xfrm>
            <a:off x="3513240" y="2570040"/>
            <a:ext cx="3024000" cy="298152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12"/>
          <a:srcRect l="17331" t="23730" r="16655" b="28438"/>
          <a:stretch/>
        </p:blipFill>
        <p:spPr>
          <a:xfrm>
            <a:off x="6789600" y="2521080"/>
            <a:ext cx="2978280" cy="305100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209520" y="360360"/>
            <a:ext cx="3024360" cy="52563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06440" y="2298600"/>
            <a:ext cx="22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ing culture parasite cou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497400" y="360360"/>
            <a:ext cx="3024000" cy="52563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565080" y="2298600"/>
            <a:ext cx="277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rophozoite culture parasite cou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753240" y="360360"/>
            <a:ext cx="3024000" cy="52563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886440" y="2298600"/>
            <a:ext cx="253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chizont culture parasite cou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4T05:06:05Z</dcterms:created>
  <dc:creator>Master</dc:creator>
  <dc:description/>
  <dc:language>en-US</dc:language>
  <cp:lastModifiedBy>Master</cp:lastModifiedBy>
  <dcterms:modified xsi:type="dcterms:W3CDTF">2015-09-04T05:26:29Z</dcterms:modified>
  <cp:revision>3</cp:revision>
  <dc:subject/>
  <dc:title>Slide 1</dc:title>
</cp:coreProperties>
</file>